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674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7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806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819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686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176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195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926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181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56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185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58D320-515E-4C78-8C3E-1612EA366E74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686B2-DBD4-4889-8660-81859C929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621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1407" y="611755"/>
            <a:ext cx="5359046" cy="208430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65" y="611754"/>
            <a:ext cx="5469774" cy="195804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3478" y="3130511"/>
            <a:ext cx="5359045" cy="208393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65" y="3246883"/>
            <a:ext cx="5469774" cy="208430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98765" y="242422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114481" y="242422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04212" y="276117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093234" y="276117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816480" y="5660967"/>
            <a:ext cx="101563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_Figure_S1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ze exclusion chromatography profile and Sodium dodecyl sulfate-polyacrylamide gel electrophoresis (SDS-PAGE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different recombinant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sing a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richT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EC 650 column in 1ⅹPB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A) T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imeric RBD; B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imeri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c-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BD; C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imeric 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ike 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buni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(S1)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imeric full-length Spike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182759" y="242422"/>
            <a:ext cx="1625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imeric RBD 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8664688" y="275434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c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BD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2523650" y="2874158"/>
            <a:ext cx="14200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imeric S1 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7486609" y="2780958"/>
            <a:ext cx="23561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imeric full-length 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8523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3</TotalTime>
  <Words>67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Company>QM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i piao</dc:creator>
  <cp:lastModifiedBy>cai piao</cp:lastModifiedBy>
  <cp:revision>7</cp:revision>
  <dcterms:created xsi:type="dcterms:W3CDTF">2022-12-12T11:59:20Z</dcterms:created>
  <dcterms:modified xsi:type="dcterms:W3CDTF">2023-01-12T09:49:03Z</dcterms:modified>
</cp:coreProperties>
</file>